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12B212"/>
    <a:srgbClr val="B21212"/>
    <a:srgbClr val="1212B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1506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237982-3392-46D2-B061-DD4F09F56FD2}" type="datetimeFigureOut">
              <a:rPr lang="ko-KR" altLang="en-US" smtClean="0"/>
              <a:t>2020-04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680C07-96CA-4CF0-8B01-2E60A534A73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840370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237982-3392-46D2-B061-DD4F09F56FD2}" type="datetimeFigureOut">
              <a:rPr lang="ko-KR" altLang="en-US" smtClean="0"/>
              <a:t>2020-04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680C07-96CA-4CF0-8B01-2E60A534A73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558413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237982-3392-46D2-B061-DD4F09F56FD2}" type="datetimeFigureOut">
              <a:rPr lang="ko-KR" altLang="en-US" smtClean="0"/>
              <a:t>2020-04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680C07-96CA-4CF0-8B01-2E60A534A73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574187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237982-3392-46D2-B061-DD4F09F56FD2}" type="datetimeFigureOut">
              <a:rPr lang="ko-KR" altLang="en-US" smtClean="0"/>
              <a:t>2020-04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680C07-96CA-4CF0-8B01-2E60A534A73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678744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237982-3392-46D2-B061-DD4F09F56FD2}" type="datetimeFigureOut">
              <a:rPr lang="ko-KR" altLang="en-US" smtClean="0"/>
              <a:t>2020-04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680C07-96CA-4CF0-8B01-2E60A534A73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97997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237982-3392-46D2-B061-DD4F09F56FD2}" type="datetimeFigureOut">
              <a:rPr lang="ko-KR" altLang="en-US" smtClean="0"/>
              <a:t>2020-04-2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680C07-96CA-4CF0-8B01-2E60A534A73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179820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237982-3392-46D2-B061-DD4F09F56FD2}" type="datetimeFigureOut">
              <a:rPr lang="ko-KR" altLang="en-US" smtClean="0"/>
              <a:t>2020-04-25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680C07-96CA-4CF0-8B01-2E60A534A73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741543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237982-3392-46D2-B061-DD4F09F56FD2}" type="datetimeFigureOut">
              <a:rPr lang="ko-KR" altLang="en-US" smtClean="0"/>
              <a:t>2020-04-25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680C07-96CA-4CF0-8B01-2E60A534A73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841670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237982-3392-46D2-B061-DD4F09F56FD2}" type="datetimeFigureOut">
              <a:rPr lang="ko-KR" altLang="en-US" smtClean="0"/>
              <a:t>2020-04-25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680C07-96CA-4CF0-8B01-2E60A534A73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038251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237982-3392-46D2-B061-DD4F09F56FD2}" type="datetimeFigureOut">
              <a:rPr lang="ko-KR" altLang="en-US" smtClean="0"/>
              <a:t>2020-04-2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680C07-96CA-4CF0-8B01-2E60A534A73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563366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237982-3392-46D2-B061-DD4F09F56FD2}" type="datetimeFigureOut">
              <a:rPr lang="ko-KR" altLang="en-US" smtClean="0"/>
              <a:t>2020-04-2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680C07-96CA-4CF0-8B01-2E60A534A73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405739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237982-3392-46D2-B061-DD4F09F56FD2}" type="datetimeFigureOut">
              <a:rPr lang="ko-KR" altLang="en-US" smtClean="0"/>
              <a:t>2020-04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680C07-96CA-4CF0-8B01-2E60A534A73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9825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>
            <a:extLst>
              <a:ext uri="{FF2B5EF4-FFF2-40B4-BE49-F238E27FC236}">
                <a16:creationId xmlns:a16="http://schemas.microsoft.com/office/drawing/2014/main" id="{07809B93-2015-469C-9896-AA31EEA0C39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9795" y="1520946"/>
            <a:ext cx="7644410" cy="3816109"/>
          </a:xfrm>
          <a:prstGeom prst="rect">
            <a:avLst/>
          </a:prstGeom>
        </p:spPr>
      </p:pic>
      <p:sp>
        <p:nvSpPr>
          <p:cNvPr id="2" name="직사각형 1">
            <a:extLst>
              <a:ext uri="{FF2B5EF4-FFF2-40B4-BE49-F238E27FC236}">
                <a16:creationId xmlns:a16="http://schemas.microsoft.com/office/drawing/2014/main" id="{5B9B1FC4-2139-430E-B5E1-63AEAEDDE9EA}"/>
              </a:ext>
            </a:extLst>
          </p:cNvPr>
          <p:cNvSpPr/>
          <p:nvPr/>
        </p:nvSpPr>
        <p:spPr>
          <a:xfrm>
            <a:off x="0" y="6425586"/>
            <a:ext cx="9144000" cy="432414"/>
          </a:xfrm>
          <a:prstGeom prst="rect">
            <a:avLst/>
          </a:prstGeom>
        </p:spPr>
        <p:txBody>
          <a:bodyPr wrap="square">
            <a:noAutofit/>
          </a:bodyPr>
          <a:lstStyle/>
          <a:p>
            <a:pPr algn="just"/>
            <a:r>
              <a:rPr lang="en-US" altLang="ko-KR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S1. The population structure of 438 soybean accessions.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e fastSTRUCTURE program was used to infer the structure of all Glycine accessions used in this study. Each group is presented by different colors.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466962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2</TotalTime>
  <Words>37</Words>
  <Application>Microsoft Office PowerPoint</Application>
  <PresentationFormat>화면 슬라이드 쇼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테마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KimJinHyun</dc:creator>
  <cp:lastModifiedBy>김 진현</cp:lastModifiedBy>
  <cp:revision>26</cp:revision>
  <dcterms:created xsi:type="dcterms:W3CDTF">2018-07-30T14:59:54Z</dcterms:created>
  <dcterms:modified xsi:type="dcterms:W3CDTF">2020-04-24T15:37:50Z</dcterms:modified>
</cp:coreProperties>
</file>